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9BDC79-5F7E-4630-BAF3-12F72070FF5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44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readsheet: C:\Documents and Settings\steinj\My Documents2\MAIZE_PROJECT\Accelerated region\Manuscript\Comp_gene_stats.x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A42E3-88B7-403D-A347-B7F8793649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6AB7E-4D0C-444F-92DF-83E2AB3E96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967AA-62CC-4D26-8E71-7E5A27B126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BB2C8-DC55-47CC-BD0B-CDABBFD0B1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0F418-7D70-40D1-8C5F-0C2F1BC947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D6482-F49E-4465-9E2C-AB43B6800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F916B-B22A-49AE-8EF1-589D64D25B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26E03-3B90-48DD-B522-AE3E94028F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C842A-BC74-4778-893E-1BFE522899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02443-A983-4B8F-B004-5F3F6BE256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93089-EF3D-4E3C-845E-2F1611836D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CC4CD-E93B-431D-960F-0CBF8B5D6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699918-2918-4384-81C8-EF67827A5D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247680" y="463680"/>
            <a:ext cx="8647200" cy="593064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141480" y="152280"/>
            <a:ext cx="70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7. Intron length discrepancies among maize, sorghum and ric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in the AR182 homologous region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5:20:36Z</dcterms:created>
  <dc:creator>fushengw</dc:creator>
  <dc:description/>
  <dc:language>en-US</dc:language>
  <cp:lastModifiedBy>fushengw</cp:lastModifiedBy>
  <dcterms:modified xsi:type="dcterms:W3CDTF">2009-10-15T05:20:54Z</dcterms:modified>
  <cp:revision>2</cp:revision>
  <dc:subject/>
  <dc:title>Slide 1</dc:title>
</cp:coreProperties>
</file>